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140754484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1"/>
    <p:restoredTop sz="96327"/>
  </p:normalViewPr>
  <p:slideViewPr>
    <p:cSldViewPr snapToGrid="0" snapToObjects="1" showGuides="1">
      <p:cViewPr varScale="1">
        <p:scale>
          <a:sx n="128" d="100"/>
          <a:sy n="128" d="100"/>
        </p:scale>
        <p:origin x="480" y="17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498B368-F1B3-0245-95A4-8A5768AB854F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C654732-3731-D34B-A754-A38BD1D2136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312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96D4B4D-86AA-2D8B-49C9-B9730EB40A9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632E16B-998E-C07C-46DF-A2A359F9AAC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AAD85-AB7F-2BD5-CC76-8617642D98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04144AE-C7EF-A1B1-3DF8-AC3A3EC46C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1874B88-59EE-7ACE-EE58-CFDE8A40AF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54129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646BCD-3DA5-7EA2-1E41-C25DCA4AA4D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20D5E7B-83C0-A78B-1F0E-DDE0115054A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BF3E42-D991-C08A-8527-15E816CAF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2D6FCB-A00A-E1AD-70BB-07A34490D23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95AEB75-EB08-C39D-B1CF-63C870406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8073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CD7C3C5-71C0-A1B2-9F1F-887D392FD73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78EE4FF-0CB6-7D57-F380-770CED4ED50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DABCBFCF-8EBD-F4B4-2D80-0B4ECE8FA2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494CF6-5D71-408F-63AF-14742B78C0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402F832-B7F9-D4D6-70EB-D52EED4B818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2236273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7_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406B85D-899C-944F-A2E0-4894DCE9224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Subtitle 2">
            <a:extLst>
              <a:ext uri="{FF2B5EF4-FFF2-40B4-BE49-F238E27FC236}">
                <a16:creationId xmlns:a16="http://schemas.microsoft.com/office/drawing/2014/main" id="{E28CA5FF-AACC-4AB7-B6E7-D6A63EA944DB}"/>
              </a:ext>
            </a:extLst>
          </p:cNvPr>
          <p:cNvSpPr>
            <a:spLocks noGrp="1"/>
          </p:cNvSpPr>
          <p:nvPr>
            <p:ph type="subTitle" idx="10" hasCustomPrompt="1"/>
          </p:nvPr>
        </p:nvSpPr>
        <p:spPr>
          <a:xfrm>
            <a:off x="614853" y="1161597"/>
            <a:ext cx="10962290" cy="276999"/>
          </a:xfrm>
        </p:spPr>
        <p:txBody>
          <a:bodyPr wrap="square">
            <a:spAutoFit/>
          </a:bodyPr>
          <a:lstStyle>
            <a:lvl1pPr marL="0" indent="0" algn="l">
              <a:buNone/>
              <a:defRPr sz="2000" b="0" i="0" baseline="0">
                <a:solidFill>
                  <a:schemeClr val="accent3"/>
                </a:solidFill>
                <a:latin typeface="+mn-lt"/>
                <a:cs typeface="Gotham Bold" pitchFamily="2" charset="0"/>
              </a:defRPr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subtitle</a:t>
            </a:r>
          </a:p>
        </p:txBody>
      </p:sp>
      <p:sp>
        <p:nvSpPr>
          <p:cNvPr id="2" name="Title 1">
            <a:extLst>
              <a:ext uri="{FF2B5EF4-FFF2-40B4-BE49-F238E27FC236}">
                <a16:creationId xmlns:a16="http://schemas.microsoft.com/office/drawing/2014/main" id="{EDEDEA15-1C46-42C0-9541-5C897D1A89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6" name="Footnotes">
            <a:extLst>
              <a:ext uri="{FF2B5EF4-FFF2-40B4-BE49-F238E27FC236}">
                <a16:creationId xmlns:a16="http://schemas.microsoft.com/office/drawing/2014/main" id="{38ABFE29-F12E-4908-BBBE-F167F72BD474}"/>
              </a:ext>
            </a:extLst>
          </p:cNvPr>
          <p:cNvSpPr>
            <a:spLocks noGrp="1"/>
          </p:cNvSpPr>
          <p:nvPr>
            <p:ph type="body" sz="quarter" idx="11" hasCustomPrompt="1"/>
          </p:nvPr>
        </p:nvSpPr>
        <p:spPr>
          <a:xfrm>
            <a:off x="614854" y="6019800"/>
            <a:ext cx="9139237" cy="352572"/>
          </a:xfrm>
        </p:spPr>
        <p:txBody>
          <a:bodyPr anchor="b">
            <a:noAutofit/>
          </a:bodyPr>
          <a:lstStyle>
            <a:lvl1pPr marL="115888" indent="-115888">
              <a:spcBef>
                <a:spcPts val="300"/>
              </a:spcBef>
              <a:spcAft>
                <a:spcPts val="0"/>
              </a:spcAft>
              <a:buFont typeface="+mj-lt"/>
              <a:buAutoNum type="arabicPeriod"/>
              <a:defRPr sz="800">
                <a:solidFill>
                  <a:schemeClr val="tx2"/>
                </a:solidFill>
                <a:latin typeface="+mn-lt"/>
              </a:defRPr>
            </a:lvl1pPr>
            <a:lvl2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2pPr>
            <a:lvl3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3pPr>
            <a:lvl4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4pPr>
            <a:lvl5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5pPr>
            <a:lvl6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6pPr>
            <a:lvl7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7pPr>
            <a:lvl8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8pPr>
            <a:lvl9pPr marL="3175" indent="-3175">
              <a:spcBef>
                <a:spcPts val="300"/>
              </a:spcBef>
              <a:spcAft>
                <a:spcPts val="0"/>
              </a:spcAft>
              <a:buFont typeface="Arial" panose="020B0604020202020204" pitchFamily="34" charset="0"/>
              <a:buChar char="​"/>
              <a:defRPr sz="800">
                <a:solidFill>
                  <a:schemeClr val="tx2"/>
                </a:solidFill>
                <a:latin typeface="+mn-lt"/>
              </a:defRPr>
            </a:lvl9pPr>
          </a:lstStyle>
          <a:p>
            <a:pPr lvl="0"/>
            <a:r>
              <a:rPr lang="en-US"/>
              <a:t>Click to add a reference</a:t>
            </a:r>
          </a:p>
        </p:txBody>
      </p:sp>
    </p:spTree>
    <p:extLst>
      <p:ext uri="{BB962C8B-B14F-4D97-AF65-F5344CB8AC3E}">
        <p14:creationId xmlns:p14="http://schemas.microsoft.com/office/powerpoint/2010/main" val="934693454"/>
      </p:ext>
    </p:extLst>
  </p:cSld>
  <p:clrMapOvr>
    <a:masterClrMapping/>
  </p:clrMapOvr>
  <p:transition spd="med">
    <p:fade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31E4477-E2C6-333E-7719-D0110A09089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F211F44-6541-C656-9423-672E6D4C77D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B29360A-D345-B9A3-98F9-2562CCC59F4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6E9D474-E09B-F229-AB05-E741B9383A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D80891-93F2-2BDA-12FD-391EF77104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27529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D10A86-25F3-EC62-2093-A0ACF40761D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8D1118-8BAB-76B5-FEC7-9E984780E62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16786A5-6961-99B3-B7EB-B08C9FB7AD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D05593-D3B5-A46B-1E20-3B42FE3BD3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DDAF183-D6B4-F12F-D3B6-BE3728054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2173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6D50339-6B24-28B7-6731-6F50E65F6F0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DFF5F1F-0CC3-D379-35E9-AD524FCE355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75D30D2-22CF-A94E-163A-05B2B4A6BD8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0F88EA-B300-6990-1E88-45239B2589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BAA1BEC-C618-848F-79D7-BA954C8898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31C6AC-69F2-5A13-03C3-3AD481CA91B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5680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627115-C71D-868B-9F4C-036DB1422F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CB570CC-37EC-5849-B1AE-CF42709C639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723A815-562C-CA29-DF83-E3B05239E1D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3DA066F-F142-A310-FBC5-11C5467C2E3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98045C0-914C-67C6-2AB6-E07E6944A4C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83214B8-9017-1262-AFAC-B7D33BC3389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F9F62EE-DAB4-B597-8FFF-B358848CD0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4D738EFA-0729-2895-CC19-0D8A1CE2B7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2937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CD62CF3-AE73-DB7D-1832-42A18399185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F82E599-7E90-14DC-69BE-FE02C24707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B84F30C-C766-9DF0-2F92-574037DD09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2463212-7AB9-4CCE-05AE-4AC30D8979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58725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050F5844-E514-2665-0563-A742A46D502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1C0F884-2473-FEBA-C949-15C20EB5D1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66191E0-7615-C448-3E88-96FC4E4BF0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065077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EBBDE2-AC71-BB30-926A-AC6C84A77F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A5F1FCB-4A60-EECB-216B-78FED4CE6C38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A9111C4-7F35-030A-B351-BEFC9876DAE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CBAEC91-AA23-18EF-976F-CE19C3A6DA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ABE547F-263A-36B2-F6EC-F1692140AA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533B1D8-A907-D8BE-F3BD-5A81D708A5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60518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32FE9E7-0B82-593B-427F-E268B23E067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7019921-432F-E8A3-FE40-2108DAC74A6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0D1C407-FD24-64F3-FB38-C90E252D594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14FE28B-DC92-0E6F-6691-8FB68A8A86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A0E5EB2-A374-0635-223E-B497A52800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65BC3EB-9B62-4587-EC39-B7B1EB86BD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410090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F579E1B-4AD0-A052-060E-38E99E5F92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AE9465-F527-A2C4-C944-745A6C335A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1C55A13-8B0A-9713-675C-36D57B45C1B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1BA2CC6-F9B3-0E4C-8F18-E150A4FE5CD5}" type="datetimeFigureOut">
              <a:rPr lang="en-US" smtClean="0"/>
              <a:t>8/1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CD0A70C-5E4E-D09F-3996-A0A001D4F96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C7EC20-85C0-BCBD-ABF8-AA0F691DADF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C64495-71CB-E748-977D-0066C06CBA3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8839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>
            <a:extLst>
              <a:ext uri="{FF2B5EF4-FFF2-40B4-BE49-F238E27FC236}">
                <a16:creationId xmlns:a16="http://schemas.microsoft.com/office/drawing/2014/main" id="{FFCC8002-5932-7943-BCBF-D5460FC72D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86531" y="229500"/>
            <a:ext cx="4170506" cy="512256"/>
          </a:xfrm>
        </p:spPr>
        <p:txBody>
          <a:bodyPr>
            <a:noAutofit/>
          </a:bodyPr>
          <a:lstStyle/>
          <a:p>
            <a:r>
              <a:rPr lang="en-US" sz="2800" dirty="0">
                <a:latin typeface="Calibri" panose="020F0502020204030204" pitchFamily="34" charset="0"/>
                <a:cs typeface="Calibri" panose="020F0502020204030204" pitchFamily="34" charset="0"/>
              </a:rPr>
              <a:t>Supplemental Figure 8</a:t>
            </a:r>
          </a:p>
        </p:txBody>
      </p:sp>
      <p:sp>
        <p:nvSpPr>
          <p:cNvPr id="5" name="Content Placeholder 1">
            <a:extLst>
              <a:ext uri="{FF2B5EF4-FFF2-40B4-BE49-F238E27FC236}">
                <a16:creationId xmlns:a16="http://schemas.microsoft.com/office/drawing/2014/main" id="{18F39F3C-F56B-9640-B152-EB6E98BDE8A8}"/>
              </a:ext>
            </a:extLst>
          </p:cNvPr>
          <p:cNvSpPr txBox="1">
            <a:spLocks/>
          </p:cNvSpPr>
          <p:nvPr/>
        </p:nvSpPr>
        <p:spPr>
          <a:xfrm>
            <a:off x="745310" y="5437149"/>
            <a:ext cx="6642093" cy="1013367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6350" algn="l" defTabSz="914400" rtl="0" eaLnBrk="1" latinLnBrk="0" hangingPunct="1">
              <a:lnSpc>
                <a:spcPct val="90000"/>
              </a:lnSpc>
              <a:spcBef>
                <a:spcPts val="1000"/>
              </a:spcBef>
              <a:spcAft>
                <a:spcPts val="600"/>
              </a:spcAft>
              <a:buFont typeface="Arial" panose="020B0604020202020204" pitchFamily="34" charset="0"/>
              <a:buChar char="​"/>
              <a:defRPr sz="2000" kern="1200">
                <a:solidFill>
                  <a:schemeClr val="tx1"/>
                </a:solidFill>
                <a:latin typeface="Gotham Bold" pitchFamily="50" charset="0"/>
                <a:ea typeface="+mn-ea"/>
                <a:cs typeface="Gotham Bold" pitchFamily="50" charset="0"/>
              </a:defRPr>
            </a:lvl1pPr>
            <a:lvl2pPr marL="1714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>
                <a:schemeClr val="accent3"/>
              </a:buClr>
              <a:buSzPct val="100000"/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2pPr>
            <a:lvl3pPr marL="4000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3pPr>
            <a:lvl4pPr marL="6286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4pPr>
            <a:lvl5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5pPr>
            <a:lvl6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6pPr>
            <a:lvl7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7pPr>
            <a:lvl8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otham Book" pitchFamily="50" charset="0"/>
              <a:buChar char="−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8pPr>
            <a:lvl9pPr marL="857250" indent="-171450" algn="l" defTabSz="914400" rtl="0" eaLnBrk="1" latinLnBrk="0" hangingPunct="1">
              <a:lnSpc>
                <a:spcPct val="90000"/>
              </a:lnSpc>
              <a:spcBef>
                <a:spcPts val="0"/>
              </a:spcBef>
              <a:spcAft>
                <a:spcPts val="600"/>
              </a:spcAft>
              <a:buClrTx/>
              <a:buSzPct val="75000"/>
              <a:buFont typeface="GT Sectra Book" panose="02000503070000020003" pitchFamily="50" charset="0"/>
              <a:buChar char="“"/>
              <a:defRPr sz="1600" kern="1200">
                <a:solidFill>
                  <a:schemeClr val="tx1"/>
                </a:solidFill>
                <a:latin typeface="Gotham Book" pitchFamily="50" charset="0"/>
                <a:ea typeface="+mn-ea"/>
                <a:cs typeface="Gotham Book" pitchFamily="50" charset="0"/>
              </a:defRPr>
            </a:lvl9pPr>
          </a:lstStyle>
          <a:p>
            <a:pPr indent="0">
              <a:buNone/>
            </a:pPr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TMB 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≥ </a:t>
            </a:r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10 treatment predictive associations is not approximated by PD-L1 CPS 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≥ </a:t>
            </a:r>
            <a:r>
              <a:rPr lang="en-US" sz="1400" b="1">
                <a:latin typeface="Calibri" panose="020F0502020204030204" pitchFamily="34" charset="0"/>
                <a:cs typeface="Calibri" panose="020F0502020204030204" pitchFamily="34" charset="0"/>
              </a:rPr>
              <a:t>10. 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Cox PH models containing treatment interaction terms for both TMB ≥ 10 and PD-L1 CPS ≥ 10 are shown numerically (A) 2</a:t>
            </a:r>
            <a:r>
              <a:rPr lang="en-US" sz="1400" baseline="30000">
                <a:latin typeface="Calibri" panose="020F0502020204030204" pitchFamily="34" charset="0"/>
                <a:cs typeface="Calibri" panose="020F0502020204030204" pitchFamily="34" charset="0"/>
              </a:rPr>
              <a:t>nd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 line cohort TTNT, (B) 2</a:t>
            </a:r>
            <a:r>
              <a:rPr lang="en-US" sz="1400" baseline="30000">
                <a:latin typeface="Calibri" panose="020F0502020204030204" pitchFamily="34" charset="0"/>
                <a:cs typeface="Calibri" panose="020F0502020204030204" pitchFamily="34" charset="0"/>
              </a:rPr>
              <a:t>nd</a:t>
            </a:r>
            <a:r>
              <a:rPr lang="en-US" sz="1400">
                <a:latin typeface="Calibri" panose="020F0502020204030204" pitchFamily="34" charset="0"/>
                <a:cs typeface="Calibri" panose="020F0502020204030204" pitchFamily="34" charset="0"/>
              </a:rPr>
              <a:t> line cohort OS, and (C) sequential cohort TTNT.  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E08C7FA-82EC-2044-91F9-0227F815F58E}"/>
              </a:ext>
            </a:extLst>
          </p:cNvPr>
          <p:cNvSpPr txBox="1"/>
          <p:nvPr/>
        </p:nvSpPr>
        <p:spPr>
          <a:xfrm>
            <a:off x="286531" y="988377"/>
            <a:ext cx="49084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A)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31FF3E80-4E7E-FA4B-B11A-36665FF40337}"/>
              </a:ext>
            </a:extLst>
          </p:cNvPr>
          <p:cNvGraphicFramePr>
            <a:graphicFrameLocks noGrp="1"/>
          </p:cNvGraphicFramePr>
          <p:nvPr/>
        </p:nvGraphicFramePr>
        <p:xfrm>
          <a:off x="745311" y="1101283"/>
          <a:ext cx="6748964" cy="12192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3441044">
                  <a:extLst>
                    <a:ext uri="{9D8B030D-6E8A-4147-A177-3AD203B41FA5}">
                      <a16:colId xmlns:a16="http://schemas.microsoft.com/office/drawing/2014/main" val="3447810742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3524243667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1566590911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479347597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402750386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9923000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13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7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8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6050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692743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 10 or mor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2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50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2.9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669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2881266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PDL1 CPS 10 or mor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9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6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4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848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0056702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: TMB10 and Treatmen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13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4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50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02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6343145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: PDL1 CPS10 and Treatmen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6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30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4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307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57320378"/>
                  </a:ext>
                </a:extLst>
              </a:tr>
            </a:tbl>
          </a:graphicData>
        </a:graphic>
      </p:graphicFrame>
      <p:sp>
        <p:nvSpPr>
          <p:cNvPr id="9" name="TextBox 8">
            <a:extLst>
              <a:ext uri="{FF2B5EF4-FFF2-40B4-BE49-F238E27FC236}">
                <a16:creationId xmlns:a16="http://schemas.microsoft.com/office/drawing/2014/main" id="{0A51B3CF-FDAB-FE45-87BE-5DC109419F1A}"/>
              </a:ext>
            </a:extLst>
          </p:cNvPr>
          <p:cNvSpPr txBox="1"/>
          <p:nvPr/>
        </p:nvSpPr>
        <p:spPr>
          <a:xfrm>
            <a:off x="286531" y="2433389"/>
            <a:ext cx="481222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B)</a:t>
            </a:r>
          </a:p>
        </p:txBody>
      </p:sp>
      <p:graphicFrame>
        <p:nvGraphicFramePr>
          <p:cNvPr id="10" name="Table 9">
            <a:extLst>
              <a:ext uri="{FF2B5EF4-FFF2-40B4-BE49-F238E27FC236}">
                <a16:creationId xmlns:a16="http://schemas.microsoft.com/office/drawing/2014/main" id="{282F0D83-6FA8-444C-841A-CF15147016A2}"/>
              </a:ext>
            </a:extLst>
          </p:cNvPr>
          <p:cNvGraphicFramePr>
            <a:graphicFrameLocks noGrp="1"/>
          </p:cNvGraphicFramePr>
          <p:nvPr/>
        </p:nvGraphicFramePr>
        <p:xfrm>
          <a:off x="745311" y="2546295"/>
          <a:ext cx="6748964" cy="12192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3441044">
                  <a:extLst>
                    <a:ext uri="{9D8B030D-6E8A-4147-A177-3AD203B41FA5}">
                      <a16:colId xmlns:a16="http://schemas.microsoft.com/office/drawing/2014/main" val="3447810742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3524243667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1566590911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479347597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402750386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9923000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23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75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2.0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411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692743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 10 or mor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83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3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85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6505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2881266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PDL1 CPS 10 or mor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60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2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2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1834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0056702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: TMB10 and Treatmen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24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9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360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6343145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: PDL1 CPS10 and Treatmen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97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33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2.85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9494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57320378"/>
                  </a:ext>
                </a:extLst>
              </a:tr>
            </a:tbl>
          </a:graphicData>
        </a:graphic>
      </p:graphicFrame>
      <p:sp>
        <p:nvSpPr>
          <p:cNvPr id="11" name="TextBox 10">
            <a:extLst>
              <a:ext uri="{FF2B5EF4-FFF2-40B4-BE49-F238E27FC236}">
                <a16:creationId xmlns:a16="http://schemas.microsoft.com/office/drawing/2014/main" id="{E1EA402C-759D-D34E-9FEF-40B797D8A8FF}"/>
              </a:ext>
            </a:extLst>
          </p:cNvPr>
          <p:cNvSpPr txBox="1"/>
          <p:nvPr/>
        </p:nvSpPr>
        <p:spPr>
          <a:xfrm>
            <a:off x="286531" y="3873829"/>
            <a:ext cx="47801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>
                <a:latin typeface="Calibri" panose="020F0502020204030204" pitchFamily="34" charset="0"/>
                <a:cs typeface="Calibri" panose="020F0502020204030204" pitchFamily="34" charset="0"/>
              </a:rPr>
              <a:t>(C)</a:t>
            </a:r>
          </a:p>
        </p:txBody>
      </p:sp>
      <p:graphicFrame>
        <p:nvGraphicFramePr>
          <p:cNvPr id="12" name="Table 11">
            <a:extLst>
              <a:ext uri="{FF2B5EF4-FFF2-40B4-BE49-F238E27FC236}">
                <a16:creationId xmlns:a16="http://schemas.microsoft.com/office/drawing/2014/main" id="{3A066C04-F919-D142-8D47-1A9A1AAC783D}"/>
              </a:ext>
            </a:extLst>
          </p:cNvPr>
          <p:cNvGraphicFramePr>
            <a:graphicFrameLocks noGrp="1"/>
          </p:cNvGraphicFramePr>
          <p:nvPr/>
        </p:nvGraphicFramePr>
        <p:xfrm>
          <a:off x="745311" y="3986735"/>
          <a:ext cx="6748964" cy="1219200"/>
        </p:xfrm>
        <a:graphic>
          <a:graphicData uri="http://schemas.openxmlformats.org/drawingml/2006/table">
            <a:tbl>
              <a:tblPr firstRow="1" bandRow="1">
                <a:tableStyleId>{8EC20E35-A176-4012-BC5E-935CFFF8708E}</a:tableStyleId>
              </a:tblPr>
              <a:tblGrid>
                <a:gridCol w="3441044">
                  <a:extLst>
                    <a:ext uri="{9D8B030D-6E8A-4147-A177-3AD203B41FA5}">
                      <a16:colId xmlns:a16="http://schemas.microsoft.com/office/drawing/2014/main" val="3447810742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3524243667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1566590911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479347597"/>
                    </a:ext>
                  </a:extLst>
                </a:gridCol>
                <a:gridCol w="826980">
                  <a:extLst>
                    <a:ext uri="{9D8B030D-6E8A-4147-A177-3AD203B41FA5}">
                      <a16:colId xmlns:a16="http://schemas.microsoft.com/office/drawing/2014/main" val="4027503863"/>
                    </a:ext>
                  </a:extLst>
                </a:gridCol>
              </a:tblGrid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variabl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HR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low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up95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u="none" strike="noStrike">
                          <a:effectLst/>
                        </a:rPr>
                        <a:t>p-valu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4199230006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CPI vs. Chemo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8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0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3.53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472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6927430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TMB 10 or mor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2.00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0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3.6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25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28812669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PDL1 CPS 10 or more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1.4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8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2.55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139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00567023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: TMB10 and Treatmen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31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006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2163431457"/>
                  </a:ext>
                </a:extLst>
              </a:tr>
              <a:tr h="203200">
                <a:tc>
                  <a:txBody>
                    <a:bodyPr/>
                    <a:lstStyle/>
                    <a:p>
                      <a:pPr algn="r" fontAlgn="b"/>
                      <a:r>
                        <a:rPr lang="en-US" sz="1200" u="none" strike="noStrike">
                          <a:effectLst/>
                        </a:rPr>
                        <a:t>Interaction Test: PDL1 CPS10 and Treatment</a:t>
                      </a:r>
                      <a:endParaRPr lang="en-US" sz="12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2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9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85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u="none" strike="noStrike">
                          <a:solidFill>
                            <a:schemeClr val="tx1"/>
                          </a:solidFill>
                          <a:effectLst/>
                        </a:rPr>
                        <a:t>0.0248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+mn-lt"/>
                      </a:endParaRPr>
                    </a:p>
                  </a:txBody>
                  <a:tcPr marL="9525" marR="9525" marT="9525" marB="0" anchor="b"/>
                </a:tc>
                <a:extLst>
                  <a:ext uri="{0D108BD9-81ED-4DB2-BD59-A6C34878D82A}">
                    <a16:rowId xmlns:a16="http://schemas.microsoft.com/office/drawing/2014/main" val="3457320378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3020712419"/>
      </p:ext>
    </p:extLst>
  </p:cSld>
  <p:clrMapOvr>
    <a:masterClrMapping/>
  </p:clrMapOvr>
  <p:transition spd="med">
    <p:fade/>
  </p:transition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</TotalTime>
  <Words>224</Words>
  <Application>Microsoft Macintosh PowerPoint</Application>
  <PresentationFormat>Widescreen</PresentationFormat>
  <Paragraphs>9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Supplemental Figure 8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l Tables &amp; Figures</dc:title>
  <dc:creator>Klempner, Samuel J.,MD</dc:creator>
  <cp:lastModifiedBy>Klempner, Samuel J.,MD</cp:lastModifiedBy>
  <cp:revision>11</cp:revision>
  <dcterms:created xsi:type="dcterms:W3CDTF">2022-06-12T16:24:02Z</dcterms:created>
  <dcterms:modified xsi:type="dcterms:W3CDTF">2022-08-13T14:34:53Z</dcterms:modified>
</cp:coreProperties>
</file>